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0" r:id="rId2"/>
    <p:sldId id="261" r:id="rId3"/>
    <p:sldId id="262" r:id="rId4"/>
  </p:sldIdLst>
  <p:sldSz cx="6011863" cy="8316913"/>
  <p:notesSz cx="6858000" cy="9144000"/>
  <p:defaultTextStyle>
    <a:defPPr>
      <a:defRPr lang="ko-KR"/>
    </a:defPPr>
    <a:lvl1pPr marL="0" algn="l" defTabSz="818721" rtl="0" eaLnBrk="1" latinLnBrk="1" hangingPunct="1">
      <a:defRPr sz="1600" kern="1200">
        <a:solidFill>
          <a:schemeClr val="tx1"/>
        </a:solidFill>
        <a:latin typeface="+mn-lt"/>
        <a:ea typeface="+mn-ea"/>
        <a:cs typeface="+mn-cs"/>
      </a:defRPr>
    </a:lvl1pPr>
    <a:lvl2pPr marL="409361" algn="l" defTabSz="818721" rtl="0" eaLnBrk="1" latinLnBrk="1" hangingPunct="1">
      <a:defRPr sz="1600" kern="1200">
        <a:solidFill>
          <a:schemeClr val="tx1"/>
        </a:solidFill>
        <a:latin typeface="+mn-lt"/>
        <a:ea typeface="+mn-ea"/>
        <a:cs typeface="+mn-cs"/>
      </a:defRPr>
    </a:lvl2pPr>
    <a:lvl3pPr marL="818721" algn="l" defTabSz="818721" rtl="0" eaLnBrk="1" latinLnBrk="1" hangingPunct="1">
      <a:defRPr sz="1600" kern="1200">
        <a:solidFill>
          <a:schemeClr val="tx1"/>
        </a:solidFill>
        <a:latin typeface="+mn-lt"/>
        <a:ea typeface="+mn-ea"/>
        <a:cs typeface="+mn-cs"/>
      </a:defRPr>
    </a:lvl3pPr>
    <a:lvl4pPr marL="1228081" algn="l" defTabSz="818721" rtl="0" eaLnBrk="1" latinLnBrk="1" hangingPunct="1">
      <a:defRPr sz="1600" kern="1200">
        <a:solidFill>
          <a:schemeClr val="tx1"/>
        </a:solidFill>
        <a:latin typeface="+mn-lt"/>
        <a:ea typeface="+mn-ea"/>
        <a:cs typeface="+mn-cs"/>
      </a:defRPr>
    </a:lvl4pPr>
    <a:lvl5pPr marL="1637442" algn="l" defTabSz="818721" rtl="0" eaLnBrk="1" latinLnBrk="1" hangingPunct="1">
      <a:defRPr sz="1600" kern="1200">
        <a:solidFill>
          <a:schemeClr val="tx1"/>
        </a:solidFill>
        <a:latin typeface="+mn-lt"/>
        <a:ea typeface="+mn-ea"/>
        <a:cs typeface="+mn-cs"/>
      </a:defRPr>
    </a:lvl5pPr>
    <a:lvl6pPr marL="2046802" algn="l" defTabSz="818721" rtl="0" eaLnBrk="1" latinLnBrk="1" hangingPunct="1">
      <a:defRPr sz="1600" kern="1200">
        <a:solidFill>
          <a:schemeClr val="tx1"/>
        </a:solidFill>
        <a:latin typeface="+mn-lt"/>
        <a:ea typeface="+mn-ea"/>
        <a:cs typeface="+mn-cs"/>
      </a:defRPr>
    </a:lvl6pPr>
    <a:lvl7pPr marL="2456162" algn="l" defTabSz="818721" rtl="0" eaLnBrk="1" latinLnBrk="1" hangingPunct="1">
      <a:defRPr sz="1600" kern="1200">
        <a:solidFill>
          <a:schemeClr val="tx1"/>
        </a:solidFill>
        <a:latin typeface="+mn-lt"/>
        <a:ea typeface="+mn-ea"/>
        <a:cs typeface="+mn-cs"/>
      </a:defRPr>
    </a:lvl7pPr>
    <a:lvl8pPr marL="2865523" algn="l" defTabSz="818721" rtl="0" eaLnBrk="1" latinLnBrk="1" hangingPunct="1">
      <a:defRPr sz="1600" kern="1200">
        <a:solidFill>
          <a:schemeClr val="tx1"/>
        </a:solidFill>
        <a:latin typeface="+mn-lt"/>
        <a:ea typeface="+mn-ea"/>
        <a:cs typeface="+mn-cs"/>
      </a:defRPr>
    </a:lvl8pPr>
    <a:lvl9pPr marL="3274883" algn="l" defTabSz="818721" rtl="0" eaLnBrk="1" latinLnBrk="1" hangingPunct="1">
      <a:defRPr sz="16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620">
          <p15:clr>
            <a:srgbClr val="A4A3A4"/>
          </p15:clr>
        </p15:guide>
        <p15:guide id="2" pos="1894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30" d="100"/>
          <a:sy n="130" d="100"/>
        </p:scale>
        <p:origin x="-732" y="2226"/>
      </p:cViewPr>
      <p:guideLst>
        <p:guide orient="horz" pos="2620"/>
        <p:guide pos="189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C920E80-D1E3-4560-AE53-30FF808B6BE9}" type="datetimeFigureOut">
              <a:rPr lang="ko-KR" altLang="en-US" smtClean="0"/>
              <a:pPr/>
              <a:t>2017-04-05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189163" y="685800"/>
            <a:ext cx="247967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A4109CC-3DF8-4AF4-9138-BBA652B0BDA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319358538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818721" rtl="0" eaLnBrk="1" latinLnBrk="1" hangingPunct="1">
      <a:defRPr sz="1100" kern="1200">
        <a:solidFill>
          <a:schemeClr val="tx1"/>
        </a:solidFill>
        <a:latin typeface="+mn-lt"/>
        <a:ea typeface="+mn-ea"/>
        <a:cs typeface="+mn-cs"/>
      </a:defRPr>
    </a:lvl1pPr>
    <a:lvl2pPr marL="409361" algn="l" defTabSz="818721" rtl="0" eaLnBrk="1" latinLnBrk="1" hangingPunct="1">
      <a:defRPr sz="1100" kern="1200">
        <a:solidFill>
          <a:schemeClr val="tx1"/>
        </a:solidFill>
        <a:latin typeface="+mn-lt"/>
        <a:ea typeface="+mn-ea"/>
        <a:cs typeface="+mn-cs"/>
      </a:defRPr>
    </a:lvl2pPr>
    <a:lvl3pPr marL="818721" algn="l" defTabSz="818721" rtl="0" eaLnBrk="1" latinLnBrk="1" hangingPunct="1">
      <a:defRPr sz="1100" kern="1200">
        <a:solidFill>
          <a:schemeClr val="tx1"/>
        </a:solidFill>
        <a:latin typeface="+mn-lt"/>
        <a:ea typeface="+mn-ea"/>
        <a:cs typeface="+mn-cs"/>
      </a:defRPr>
    </a:lvl3pPr>
    <a:lvl4pPr marL="1228081" algn="l" defTabSz="818721" rtl="0" eaLnBrk="1" latinLnBrk="1" hangingPunct="1">
      <a:defRPr sz="1100" kern="1200">
        <a:solidFill>
          <a:schemeClr val="tx1"/>
        </a:solidFill>
        <a:latin typeface="+mn-lt"/>
        <a:ea typeface="+mn-ea"/>
        <a:cs typeface="+mn-cs"/>
      </a:defRPr>
    </a:lvl4pPr>
    <a:lvl5pPr marL="1637442" algn="l" defTabSz="818721" rtl="0" eaLnBrk="1" latinLnBrk="1" hangingPunct="1">
      <a:defRPr sz="1100" kern="1200">
        <a:solidFill>
          <a:schemeClr val="tx1"/>
        </a:solidFill>
        <a:latin typeface="+mn-lt"/>
        <a:ea typeface="+mn-ea"/>
        <a:cs typeface="+mn-cs"/>
      </a:defRPr>
    </a:lvl5pPr>
    <a:lvl6pPr marL="2046802" algn="l" defTabSz="818721" rtl="0" eaLnBrk="1" latinLnBrk="1" hangingPunct="1">
      <a:defRPr sz="1100" kern="1200">
        <a:solidFill>
          <a:schemeClr val="tx1"/>
        </a:solidFill>
        <a:latin typeface="+mn-lt"/>
        <a:ea typeface="+mn-ea"/>
        <a:cs typeface="+mn-cs"/>
      </a:defRPr>
    </a:lvl6pPr>
    <a:lvl7pPr marL="2456162" algn="l" defTabSz="818721" rtl="0" eaLnBrk="1" latinLnBrk="1" hangingPunct="1">
      <a:defRPr sz="1100" kern="1200">
        <a:solidFill>
          <a:schemeClr val="tx1"/>
        </a:solidFill>
        <a:latin typeface="+mn-lt"/>
        <a:ea typeface="+mn-ea"/>
        <a:cs typeface="+mn-cs"/>
      </a:defRPr>
    </a:lvl7pPr>
    <a:lvl8pPr marL="2865523" algn="l" defTabSz="818721" rtl="0" eaLnBrk="1" latinLnBrk="1" hangingPunct="1">
      <a:defRPr sz="1100" kern="1200">
        <a:solidFill>
          <a:schemeClr val="tx1"/>
        </a:solidFill>
        <a:latin typeface="+mn-lt"/>
        <a:ea typeface="+mn-ea"/>
        <a:cs typeface="+mn-cs"/>
      </a:defRPr>
    </a:lvl8pPr>
    <a:lvl9pPr marL="3274883" algn="l" defTabSz="818721" rtl="0" eaLnBrk="1" latinLnBrk="1" hangingPunct="1">
      <a:defRPr sz="11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450890" y="2583635"/>
            <a:ext cx="5110084" cy="1782746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901780" y="4712918"/>
            <a:ext cx="4208304" cy="21254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0936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81872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2280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63744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04680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45616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86552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27488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1815D-F702-42E3-BA42-C3832D5A3F6A}" type="datetimeFigureOut">
              <a:rPr lang="ko-KR" altLang="en-US" smtClean="0"/>
              <a:pPr/>
              <a:t>2017-04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60350F-BA5E-41D9-AA9B-8FB768D9549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2150355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1815D-F702-42E3-BA42-C3832D5A3F6A}" type="datetimeFigureOut">
              <a:rPr lang="ko-KR" altLang="en-US" smtClean="0"/>
              <a:pPr/>
              <a:t>2017-04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60350F-BA5E-41D9-AA9B-8FB768D9549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4396455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4577783" y="621844"/>
            <a:ext cx="1420512" cy="13247379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315205" y="621844"/>
            <a:ext cx="4162380" cy="13247379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1815D-F702-42E3-BA42-C3832D5A3F6A}" type="datetimeFigureOut">
              <a:rPr lang="ko-KR" altLang="en-US" smtClean="0"/>
              <a:pPr/>
              <a:t>2017-04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60350F-BA5E-41D9-AA9B-8FB768D9549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8876687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1815D-F702-42E3-BA42-C3832D5A3F6A}" type="datetimeFigureOut">
              <a:rPr lang="ko-KR" altLang="en-US" smtClean="0"/>
              <a:pPr/>
              <a:t>2017-04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60350F-BA5E-41D9-AA9B-8FB768D9549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9081369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74896" y="5344388"/>
            <a:ext cx="5110084" cy="1651831"/>
          </a:xfrm>
        </p:spPr>
        <p:txBody>
          <a:bodyPr anchor="t"/>
          <a:lstStyle>
            <a:lvl1pPr algn="l">
              <a:defRPr sz="36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74896" y="3525063"/>
            <a:ext cx="5110084" cy="1819324"/>
          </a:xfrm>
        </p:spPr>
        <p:txBody>
          <a:bodyPr anchor="b"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40936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818721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3pPr>
            <a:lvl4pPr marL="1228081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4pPr>
            <a:lvl5pPr marL="1637442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5pPr>
            <a:lvl6pPr marL="2046802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6pPr>
            <a:lvl7pPr marL="2456162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7pPr>
            <a:lvl8pPr marL="2865523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8pPr>
            <a:lvl9pPr marL="3274883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1815D-F702-42E3-BA42-C3832D5A3F6A}" type="datetimeFigureOut">
              <a:rPr lang="ko-KR" altLang="en-US" smtClean="0"/>
              <a:pPr/>
              <a:t>2017-04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60350F-BA5E-41D9-AA9B-8FB768D9549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40328596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315206" y="3623248"/>
            <a:ext cx="2790924" cy="10245975"/>
          </a:xfrm>
        </p:spPr>
        <p:txBody>
          <a:bodyPr/>
          <a:lstStyle>
            <a:lvl1pPr>
              <a:defRPr sz="2500"/>
            </a:lvl1pPr>
            <a:lvl2pPr>
              <a:defRPr sz="22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206327" y="3623248"/>
            <a:ext cx="2791968" cy="10245975"/>
          </a:xfrm>
        </p:spPr>
        <p:txBody>
          <a:bodyPr/>
          <a:lstStyle>
            <a:lvl1pPr>
              <a:defRPr sz="2500"/>
            </a:lvl1pPr>
            <a:lvl2pPr>
              <a:defRPr sz="22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1815D-F702-42E3-BA42-C3832D5A3F6A}" type="datetimeFigureOut">
              <a:rPr lang="ko-KR" altLang="en-US" smtClean="0"/>
              <a:pPr/>
              <a:t>2017-04-0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60350F-BA5E-41D9-AA9B-8FB768D9549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1674705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00594" y="333063"/>
            <a:ext cx="5410677" cy="1386152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00593" y="1861680"/>
            <a:ext cx="2656284" cy="775860"/>
          </a:xfrm>
        </p:spPr>
        <p:txBody>
          <a:bodyPr anchor="b"/>
          <a:lstStyle>
            <a:lvl1pPr marL="0" indent="0">
              <a:buNone/>
              <a:defRPr sz="2200" b="1"/>
            </a:lvl1pPr>
            <a:lvl2pPr marL="409361" indent="0">
              <a:buNone/>
              <a:defRPr sz="1800" b="1"/>
            </a:lvl2pPr>
            <a:lvl3pPr marL="818721" indent="0">
              <a:buNone/>
              <a:defRPr sz="1600" b="1"/>
            </a:lvl3pPr>
            <a:lvl4pPr marL="1228081" indent="0">
              <a:buNone/>
              <a:defRPr sz="1400" b="1"/>
            </a:lvl4pPr>
            <a:lvl5pPr marL="1637442" indent="0">
              <a:buNone/>
              <a:defRPr sz="1400" b="1"/>
            </a:lvl5pPr>
            <a:lvl6pPr marL="2046802" indent="0">
              <a:buNone/>
              <a:defRPr sz="1400" b="1"/>
            </a:lvl6pPr>
            <a:lvl7pPr marL="2456162" indent="0">
              <a:buNone/>
              <a:defRPr sz="1400" b="1"/>
            </a:lvl7pPr>
            <a:lvl8pPr marL="2865523" indent="0">
              <a:buNone/>
              <a:defRPr sz="1400" b="1"/>
            </a:lvl8pPr>
            <a:lvl9pPr marL="3274883" indent="0">
              <a:buNone/>
              <a:defRPr sz="14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00593" y="2637540"/>
            <a:ext cx="2656284" cy="4791852"/>
          </a:xfrm>
        </p:spPr>
        <p:txBody>
          <a:bodyPr/>
          <a:lstStyle>
            <a:lvl1pPr>
              <a:defRPr sz="2200"/>
            </a:lvl1pPr>
            <a:lvl2pPr>
              <a:defRPr sz="1800"/>
            </a:lvl2pPr>
            <a:lvl3pPr>
              <a:defRPr sz="16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053943" y="1861680"/>
            <a:ext cx="2657327" cy="775860"/>
          </a:xfrm>
        </p:spPr>
        <p:txBody>
          <a:bodyPr anchor="b"/>
          <a:lstStyle>
            <a:lvl1pPr marL="0" indent="0">
              <a:buNone/>
              <a:defRPr sz="2200" b="1"/>
            </a:lvl1pPr>
            <a:lvl2pPr marL="409361" indent="0">
              <a:buNone/>
              <a:defRPr sz="1800" b="1"/>
            </a:lvl2pPr>
            <a:lvl3pPr marL="818721" indent="0">
              <a:buNone/>
              <a:defRPr sz="1600" b="1"/>
            </a:lvl3pPr>
            <a:lvl4pPr marL="1228081" indent="0">
              <a:buNone/>
              <a:defRPr sz="1400" b="1"/>
            </a:lvl4pPr>
            <a:lvl5pPr marL="1637442" indent="0">
              <a:buNone/>
              <a:defRPr sz="1400" b="1"/>
            </a:lvl5pPr>
            <a:lvl6pPr marL="2046802" indent="0">
              <a:buNone/>
              <a:defRPr sz="1400" b="1"/>
            </a:lvl6pPr>
            <a:lvl7pPr marL="2456162" indent="0">
              <a:buNone/>
              <a:defRPr sz="1400" b="1"/>
            </a:lvl7pPr>
            <a:lvl8pPr marL="2865523" indent="0">
              <a:buNone/>
              <a:defRPr sz="1400" b="1"/>
            </a:lvl8pPr>
            <a:lvl9pPr marL="3274883" indent="0">
              <a:buNone/>
              <a:defRPr sz="14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053943" y="2637540"/>
            <a:ext cx="2657327" cy="4791852"/>
          </a:xfrm>
        </p:spPr>
        <p:txBody>
          <a:bodyPr/>
          <a:lstStyle>
            <a:lvl1pPr>
              <a:defRPr sz="2200"/>
            </a:lvl1pPr>
            <a:lvl2pPr>
              <a:defRPr sz="1800"/>
            </a:lvl2pPr>
            <a:lvl3pPr>
              <a:defRPr sz="16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1815D-F702-42E3-BA42-C3832D5A3F6A}" type="datetimeFigureOut">
              <a:rPr lang="ko-KR" altLang="en-US" smtClean="0"/>
              <a:pPr/>
              <a:t>2017-04-05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60350F-BA5E-41D9-AA9B-8FB768D9549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9466141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1815D-F702-42E3-BA42-C3832D5A3F6A}" type="datetimeFigureOut">
              <a:rPr lang="ko-KR" altLang="en-US" smtClean="0"/>
              <a:pPr/>
              <a:t>2017-04-05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60350F-BA5E-41D9-AA9B-8FB768D9549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0438650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1815D-F702-42E3-BA42-C3832D5A3F6A}" type="datetimeFigureOut">
              <a:rPr lang="ko-KR" altLang="en-US" smtClean="0"/>
              <a:pPr/>
              <a:t>2017-04-05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60350F-BA5E-41D9-AA9B-8FB768D9549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4559426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00594" y="331137"/>
            <a:ext cx="1977861" cy="1409255"/>
          </a:xfrm>
        </p:spPr>
        <p:txBody>
          <a:bodyPr anchor="b"/>
          <a:lstStyle>
            <a:lvl1pPr algn="l">
              <a:defRPr sz="18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350472" y="331137"/>
            <a:ext cx="3360798" cy="7098255"/>
          </a:xfrm>
        </p:spPr>
        <p:txBody>
          <a:bodyPr/>
          <a:lstStyle>
            <a:lvl1pPr>
              <a:defRPr sz="2900"/>
            </a:lvl1pPr>
            <a:lvl2pPr>
              <a:defRPr sz="2500"/>
            </a:lvl2pPr>
            <a:lvl3pPr>
              <a:defRPr sz="22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00594" y="1740392"/>
            <a:ext cx="1977861" cy="5689000"/>
          </a:xfrm>
        </p:spPr>
        <p:txBody>
          <a:bodyPr/>
          <a:lstStyle>
            <a:lvl1pPr marL="0" indent="0">
              <a:buNone/>
              <a:defRPr sz="1300"/>
            </a:lvl1pPr>
            <a:lvl2pPr marL="409361" indent="0">
              <a:buNone/>
              <a:defRPr sz="1100"/>
            </a:lvl2pPr>
            <a:lvl3pPr marL="818721" indent="0">
              <a:buNone/>
              <a:defRPr sz="900"/>
            </a:lvl3pPr>
            <a:lvl4pPr marL="1228081" indent="0">
              <a:buNone/>
              <a:defRPr sz="800"/>
            </a:lvl4pPr>
            <a:lvl5pPr marL="1637442" indent="0">
              <a:buNone/>
              <a:defRPr sz="800"/>
            </a:lvl5pPr>
            <a:lvl6pPr marL="2046802" indent="0">
              <a:buNone/>
              <a:defRPr sz="800"/>
            </a:lvl6pPr>
            <a:lvl7pPr marL="2456162" indent="0">
              <a:buNone/>
              <a:defRPr sz="800"/>
            </a:lvl7pPr>
            <a:lvl8pPr marL="2865523" indent="0">
              <a:buNone/>
              <a:defRPr sz="800"/>
            </a:lvl8pPr>
            <a:lvl9pPr marL="3274883" indent="0">
              <a:buNone/>
              <a:defRPr sz="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1815D-F702-42E3-BA42-C3832D5A3F6A}" type="datetimeFigureOut">
              <a:rPr lang="ko-KR" altLang="en-US" smtClean="0"/>
              <a:pPr/>
              <a:t>2017-04-0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60350F-BA5E-41D9-AA9B-8FB768D9549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0854836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178368" y="5821839"/>
            <a:ext cx="3607118" cy="687301"/>
          </a:xfrm>
        </p:spPr>
        <p:txBody>
          <a:bodyPr anchor="b"/>
          <a:lstStyle>
            <a:lvl1pPr algn="l">
              <a:defRPr sz="18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178368" y="743132"/>
            <a:ext cx="3607118" cy="4990148"/>
          </a:xfrm>
        </p:spPr>
        <p:txBody>
          <a:bodyPr/>
          <a:lstStyle>
            <a:lvl1pPr marL="0" indent="0">
              <a:buNone/>
              <a:defRPr sz="2900"/>
            </a:lvl1pPr>
            <a:lvl2pPr marL="409361" indent="0">
              <a:buNone/>
              <a:defRPr sz="2500"/>
            </a:lvl2pPr>
            <a:lvl3pPr marL="818721" indent="0">
              <a:buNone/>
              <a:defRPr sz="2200"/>
            </a:lvl3pPr>
            <a:lvl4pPr marL="1228081" indent="0">
              <a:buNone/>
              <a:defRPr sz="1800"/>
            </a:lvl4pPr>
            <a:lvl5pPr marL="1637442" indent="0">
              <a:buNone/>
              <a:defRPr sz="1800"/>
            </a:lvl5pPr>
            <a:lvl6pPr marL="2046802" indent="0">
              <a:buNone/>
              <a:defRPr sz="1800"/>
            </a:lvl6pPr>
            <a:lvl7pPr marL="2456162" indent="0">
              <a:buNone/>
              <a:defRPr sz="1800"/>
            </a:lvl7pPr>
            <a:lvl8pPr marL="2865523" indent="0">
              <a:buNone/>
              <a:defRPr sz="1800"/>
            </a:lvl8pPr>
            <a:lvl9pPr marL="3274883" indent="0">
              <a:buNone/>
              <a:defRPr sz="18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178368" y="6509141"/>
            <a:ext cx="3607118" cy="976081"/>
          </a:xfrm>
        </p:spPr>
        <p:txBody>
          <a:bodyPr/>
          <a:lstStyle>
            <a:lvl1pPr marL="0" indent="0">
              <a:buNone/>
              <a:defRPr sz="1300"/>
            </a:lvl1pPr>
            <a:lvl2pPr marL="409361" indent="0">
              <a:buNone/>
              <a:defRPr sz="1100"/>
            </a:lvl2pPr>
            <a:lvl3pPr marL="818721" indent="0">
              <a:buNone/>
              <a:defRPr sz="900"/>
            </a:lvl3pPr>
            <a:lvl4pPr marL="1228081" indent="0">
              <a:buNone/>
              <a:defRPr sz="800"/>
            </a:lvl4pPr>
            <a:lvl5pPr marL="1637442" indent="0">
              <a:buNone/>
              <a:defRPr sz="800"/>
            </a:lvl5pPr>
            <a:lvl6pPr marL="2046802" indent="0">
              <a:buNone/>
              <a:defRPr sz="800"/>
            </a:lvl6pPr>
            <a:lvl7pPr marL="2456162" indent="0">
              <a:buNone/>
              <a:defRPr sz="800"/>
            </a:lvl7pPr>
            <a:lvl8pPr marL="2865523" indent="0">
              <a:buNone/>
              <a:defRPr sz="800"/>
            </a:lvl8pPr>
            <a:lvl9pPr marL="3274883" indent="0">
              <a:buNone/>
              <a:defRPr sz="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1815D-F702-42E3-BA42-C3832D5A3F6A}" type="datetimeFigureOut">
              <a:rPr lang="ko-KR" altLang="en-US" smtClean="0"/>
              <a:pPr/>
              <a:t>2017-04-0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60350F-BA5E-41D9-AA9B-8FB768D9549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1613933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00594" y="333063"/>
            <a:ext cx="5410677" cy="1386152"/>
          </a:xfrm>
          <a:prstGeom prst="rect">
            <a:avLst/>
          </a:prstGeom>
        </p:spPr>
        <p:txBody>
          <a:bodyPr vert="horz" lIns="81872" tIns="40936" rIns="81872" bIns="40936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00594" y="1940614"/>
            <a:ext cx="5410677" cy="5488778"/>
          </a:xfrm>
          <a:prstGeom prst="rect">
            <a:avLst/>
          </a:prstGeom>
        </p:spPr>
        <p:txBody>
          <a:bodyPr vert="horz" lIns="81872" tIns="40936" rIns="81872" bIns="40936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00593" y="7708548"/>
            <a:ext cx="1402768" cy="442798"/>
          </a:xfrm>
          <a:prstGeom prst="rect">
            <a:avLst/>
          </a:prstGeom>
        </p:spPr>
        <p:txBody>
          <a:bodyPr vert="horz" lIns="81872" tIns="40936" rIns="81872" bIns="40936" rtlCol="0" anchor="ctr"/>
          <a:lstStyle>
            <a:lvl1pPr algn="l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E1815D-F702-42E3-BA42-C3832D5A3F6A}" type="datetimeFigureOut">
              <a:rPr lang="ko-KR" altLang="en-US" smtClean="0"/>
              <a:pPr/>
              <a:t>2017-04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054054" y="7708548"/>
            <a:ext cx="1903757" cy="442798"/>
          </a:xfrm>
          <a:prstGeom prst="rect">
            <a:avLst/>
          </a:prstGeom>
        </p:spPr>
        <p:txBody>
          <a:bodyPr vert="horz" lIns="81872" tIns="40936" rIns="81872" bIns="40936" rtlCol="0" anchor="ctr"/>
          <a:lstStyle>
            <a:lvl1pPr algn="ct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308502" y="7708548"/>
            <a:ext cx="1402768" cy="442798"/>
          </a:xfrm>
          <a:prstGeom prst="rect">
            <a:avLst/>
          </a:prstGeom>
        </p:spPr>
        <p:txBody>
          <a:bodyPr vert="horz" lIns="81872" tIns="40936" rIns="81872" bIns="40936" rtlCol="0" anchor="ctr"/>
          <a:lstStyle>
            <a:lvl1pPr algn="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60350F-BA5E-41D9-AA9B-8FB768D9549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2358203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818721" rtl="0" eaLnBrk="1" latinLnBrk="1" hangingPunct="1">
        <a:spcBef>
          <a:spcPct val="0"/>
        </a:spcBef>
        <a:buNone/>
        <a:defRPr sz="40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7020" indent="-307020" algn="l" defTabSz="818721" rtl="0" eaLnBrk="1" latinLnBrk="1" hangingPunct="1">
        <a:spcBef>
          <a:spcPct val="20000"/>
        </a:spcBef>
        <a:buFont typeface="Arial" panose="020B0604020202020204" pitchFamily="34" charset="0"/>
        <a:buChar char="•"/>
        <a:defRPr sz="2900" kern="1200">
          <a:solidFill>
            <a:schemeClr val="tx1"/>
          </a:solidFill>
          <a:latin typeface="+mn-lt"/>
          <a:ea typeface="+mn-ea"/>
          <a:cs typeface="+mn-cs"/>
        </a:defRPr>
      </a:lvl1pPr>
      <a:lvl2pPr marL="665210" indent="-255851" algn="l" defTabSz="818721" rtl="0" eaLnBrk="1" latinLnBrk="1" hangingPunct="1">
        <a:spcBef>
          <a:spcPct val="20000"/>
        </a:spcBef>
        <a:buFont typeface="Arial" panose="020B0604020202020204" pitchFamily="34" charset="0"/>
        <a:buChar char="–"/>
        <a:defRPr sz="2500" kern="1200">
          <a:solidFill>
            <a:schemeClr val="tx1"/>
          </a:solidFill>
          <a:latin typeface="+mn-lt"/>
          <a:ea typeface="+mn-ea"/>
          <a:cs typeface="+mn-cs"/>
        </a:defRPr>
      </a:lvl2pPr>
      <a:lvl3pPr marL="1023401" indent="-204680" algn="l" defTabSz="818721" rtl="0" eaLnBrk="1" latinLnBrk="1" hangingPunct="1">
        <a:spcBef>
          <a:spcPct val="20000"/>
        </a:spcBef>
        <a:buFont typeface="Arial" panose="020B0604020202020204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3pPr>
      <a:lvl4pPr marL="1432761" indent="-204680" algn="l" defTabSz="818721" rtl="0" eaLnBrk="1" latinLnBrk="1" hangingPunct="1">
        <a:spcBef>
          <a:spcPct val="20000"/>
        </a:spcBef>
        <a:buFont typeface="Arial" panose="020B0604020202020204" pitchFamily="34" charset="0"/>
        <a:buChar char="–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42122" indent="-204680" algn="l" defTabSz="818721" rtl="0" eaLnBrk="1" latinLnBrk="1" hangingPunct="1">
        <a:spcBef>
          <a:spcPct val="20000"/>
        </a:spcBef>
        <a:buFont typeface="Arial" panose="020B0604020202020204" pitchFamily="34" charset="0"/>
        <a:buChar char="»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51482" indent="-204680" algn="l" defTabSz="818721" rtl="0" eaLnBrk="1" latinLnBrk="1" hangingPunct="1">
        <a:spcBef>
          <a:spcPct val="200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660842" indent="-204680" algn="l" defTabSz="818721" rtl="0" eaLnBrk="1" latinLnBrk="1" hangingPunct="1">
        <a:spcBef>
          <a:spcPct val="200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070203" indent="-204680" algn="l" defTabSz="818721" rtl="0" eaLnBrk="1" latinLnBrk="1" hangingPunct="1">
        <a:spcBef>
          <a:spcPct val="200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479564" indent="-204680" algn="l" defTabSz="818721" rtl="0" eaLnBrk="1" latinLnBrk="1" hangingPunct="1">
        <a:spcBef>
          <a:spcPct val="200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818721" rtl="0" eaLnBrk="1" latinLnBrk="1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1pPr>
      <a:lvl2pPr marL="409361" algn="l" defTabSz="818721" rtl="0" eaLnBrk="1" latinLnBrk="1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2pPr>
      <a:lvl3pPr marL="818721" algn="l" defTabSz="818721" rtl="0" eaLnBrk="1" latinLnBrk="1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28081" algn="l" defTabSz="818721" rtl="0" eaLnBrk="1" latinLnBrk="1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4pPr>
      <a:lvl5pPr marL="1637442" algn="l" defTabSz="818721" rtl="0" eaLnBrk="1" latinLnBrk="1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5pPr>
      <a:lvl6pPr marL="2046802" algn="l" defTabSz="818721" rtl="0" eaLnBrk="1" latinLnBrk="1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6pPr>
      <a:lvl7pPr marL="2456162" algn="l" defTabSz="818721" rtl="0" eaLnBrk="1" latinLnBrk="1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7pPr>
      <a:lvl8pPr marL="2865523" algn="l" defTabSz="818721" rtl="0" eaLnBrk="1" latinLnBrk="1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8pPr>
      <a:lvl9pPr marL="3274883" algn="l" defTabSz="818721" rtl="0" eaLnBrk="1" latinLnBrk="1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874432" y="7853775"/>
            <a:ext cx="2263001" cy="299896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15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1.</a:t>
            </a:r>
            <a:endParaRPr lang="ko-KR" altLang="en-US" sz="1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표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4198363733"/>
              </p:ext>
            </p:extLst>
          </p:nvPr>
        </p:nvGraphicFramePr>
        <p:xfrm>
          <a:off x="177106" y="1024452"/>
          <a:ext cx="5657651" cy="27733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428808"/>
                <a:gridCol w="4228843"/>
              </a:tblGrid>
              <a:tr h="257396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3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</a:t>
                      </a:r>
                      <a:endParaRPr lang="ko-KR" altLang="en-US" sz="13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3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 sequence</a:t>
                      </a:r>
                      <a:endParaRPr lang="ko-KR" altLang="en-US" sz="13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246" marR="57246" marT="29700" marB="29700"/>
                </a:tc>
              </a:tr>
              <a:tr h="257396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3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volin-1</a:t>
                      </a:r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s-ES" altLang="ko-KR" sz="13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CCA GAA GGG ACA CAC AGU U </a:t>
                      </a:r>
                      <a:r>
                        <a:rPr lang="es-ES" altLang="ko-KR" sz="1300" b="1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dTdT)-3’</a:t>
                      </a:r>
                      <a:endParaRPr lang="ko-KR" altLang="en-US" sz="13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246" marR="57246" marT="29700" marB="29700"/>
                </a:tc>
              </a:tr>
              <a:tr h="257396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3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volin-1</a:t>
                      </a:r>
                      <a:endParaRPr lang="ko-KR" altLang="en-US" sz="13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r>
                        <a:rPr lang="en-US" altLang="ko-KR" sz="1300" b="1" i="0" u="none" strike="noStrike" kern="1200" baseline="0" dirty="0" smtClean="0">
                          <a:solidFill>
                            <a:schemeClr val="dk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’-GCA UUU GGA AGG CCA GCU U (</a:t>
                      </a:r>
                      <a:r>
                        <a:rPr lang="en-US" altLang="ko-KR" sz="1300" b="1" i="0" u="none" strike="noStrike" kern="1200" baseline="0" dirty="0" err="1" smtClean="0">
                          <a:solidFill>
                            <a:schemeClr val="dk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dTdT</a:t>
                      </a:r>
                      <a:r>
                        <a:rPr lang="en-US" altLang="ko-KR" sz="1300" b="1" i="0" u="none" strike="noStrike" kern="1200" baseline="0" dirty="0" smtClean="0">
                          <a:solidFill>
                            <a:schemeClr val="dk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)-3’</a:t>
                      </a:r>
                      <a:endParaRPr lang="ko-KR" altLang="en-US" sz="13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246" marR="57246" marT="29700" marB="29700"/>
                </a:tc>
              </a:tr>
              <a:tr h="257396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3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volin-1</a:t>
                      </a:r>
                      <a:endParaRPr lang="ko-KR" altLang="en-US" sz="13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3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</a:t>
                      </a:r>
                      <a:r>
                        <a:rPr lang="en-US" altLang="ko-KR" sz="1300" b="1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A ACT AAT GCC TTA CTC T (</a:t>
                      </a:r>
                      <a:r>
                        <a:rPr lang="en-US" altLang="ko-KR" sz="1300" b="1" baseline="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TdT</a:t>
                      </a:r>
                      <a:r>
                        <a:rPr lang="en-US" altLang="ko-KR" sz="1300" b="1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-3’</a:t>
                      </a:r>
                      <a:endParaRPr lang="ko-KR" altLang="en-US" sz="13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246" marR="57246" marT="29700" marB="29700"/>
                </a:tc>
              </a:tr>
              <a:tr h="257396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3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53</a:t>
                      </a:r>
                      <a:endParaRPr lang="ko-KR" altLang="en-US" sz="13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3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CAC</a:t>
                      </a:r>
                      <a:r>
                        <a:rPr lang="en-US" altLang="ko-KR" sz="1300" b="1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UAC AAC UAC AUG UGU A (</a:t>
                      </a:r>
                      <a:r>
                        <a:rPr lang="en-US" altLang="ko-KR" sz="1300" b="1" baseline="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TdT</a:t>
                      </a:r>
                      <a:r>
                        <a:rPr lang="en-US" altLang="ko-KR" sz="1300" b="1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-3’</a:t>
                      </a:r>
                      <a:endParaRPr lang="ko-KR" altLang="en-US" sz="13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246" marR="57246" marT="29700" marB="29700"/>
                </a:tc>
              </a:tr>
              <a:tr h="257396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3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21</a:t>
                      </a:r>
                      <a:endParaRPr lang="ko-KR" altLang="en-US" sz="13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3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CUG UAC UGU UCU GUG UCU U (</a:t>
                      </a:r>
                      <a:r>
                        <a:rPr lang="en-US" altLang="ko-KR" sz="1300" b="1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TdT</a:t>
                      </a:r>
                      <a:r>
                        <a:rPr lang="en-US" altLang="ko-KR" sz="13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-3’</a:t>
                      </a:r>
                      <a:endParaRPr lang="ko-KR" altLang="en-US" sz="13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246" marR="57246" marT="29700" marB="29700"/>
                </a:tc>
              </a:tr>
              <a:tr h="257396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3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DUFV1</a:t>
                      </a:r>
                      <a:endParaRPr lang="ko-KR" altLang="en-US" sz="13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3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GAG</a:t>
                      </a:r>
                      <a:r>
                        <a:rPr lang="en-US" altLang="ko-KR" sz="1300" b="1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UU CAU GAA UAA GCC CUC AGA U (</a:t>
                      </a:r>
                      <a:r>
                        <a:rPr lang="en-US" altLang="ko-KR" sz="1300" b="1" baseline="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TdT</a:t>
                      </a:r>
                      <a:r>
                        <a:rPr lang="en-US" altLang="ko-KR" sz="1300" b="1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-3’</a:t>
                      </a:r>
                      <a:endParaRPr lang="ko-KR" altLang="en-US" sz="13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246" marR="57246" marT="29700" marB="29700"/>
                </a:tc>
              </a:tr>
              <a:tr h="257396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3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S1</a:t>
                      </a:r>
                      <a:endParaRPr lang="ko-KR" altLang="en-US" sz="13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marL="0" marR="0" indent="0" algn="l" defTabSz="818721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3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CAGCGACAAAGAAACAGATATTGAT </a:t>
                      </a:r>
                      <a:r>
                        <a:rPr lang="en-US" altLang="ko-KR" sz="1300" b="1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altLang="ko-KR" sz="1300" b="1" baseline="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TdT</a:t>
                      </a:r>
                      <a:r>
                        <a:rPr lang="en-US" altLang="ko-KR" sz="1300" b="1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-</a:t>
                      </a:r>
                      <a:r>
                        <a:rPr lang="en-US" altLang="ko-KR" sz="1300" b="1" baseline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’</a:t>
                      </a:r>
                      <a:endParaRPr lang="ko-KR" altLang="en-US" sz="1300" b="1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246" marR="57246" marT="29700" marB="29700"/>
                </a:tc>
              </a:tr>
              <a:tr h="257396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3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S1</a:t>
                      </a:r>
                      <a:endParaRPr lang="ko-KR" altLang="en-US" sz="13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marL="0" marR="0" indent="0" algn="l" defTabSz="818721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3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TGGGATCCTTCATGCTGATGCTTCT  </a:t>
                      </a:r>
                      <a:r>
                        <a:rPr lang="en-US" altLang="ko-KR" sz="1300" b="1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altLang="ko-KR" sz="1300" b="1" baseline="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TdT</a:t>
                      </a:r>
                      <a:r>
                        <a:rPr lang="en-US" altLang="ko-KR" sz="1300" b="1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-3’</a:t>
                      </a:r>
                      <a:endParaRPr lang="ko-KR" altLang="en-US" sz="1300" b="1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246" marR="57246" marT="29700" marB="29700"/>
                </a:tc>
              </a:tr>
              <a:tr h="257396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3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</a:t>
                      </a:r>
                      <a:endParaRPr lang="ko-KR" altLang="en-US" sz="13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3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CCU ACG CCA </a:t>
                      </a:r>
                      <a:r>
                        <a:rPr lang="en-US" altLang="ko-KR" sz="1300" b="1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A</a:t>
                      </a:r>
                      <a:r>
                        <a:rPr lang="en-US" altLang="ko-KR" sz="13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UU UCG U (</a:t>
                      </a:r>
                      <a:r>
                        <a:rPr lang="en-US" altLang="ko-KR" sz="1300" b="1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TdT</a:t>
                      </a:r>
                      <a:r>
                        <a:rPr lang="en-US" altLang="ko-KR" sz="13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-3’</a:t>
                      </a:r>
                      <a:endParaRPr lang="ko-KR" altLang="en-US" sz="13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246" marR="57246" marT="29700" marB="29700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xmlns="" val="22009127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874432" y="7853775"/>
            <a:ext cx="2263001" cy="299896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15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2.</a:t>
            </a:r>
            <a:endParaRPr lang="ko-KR" altLang="en-US" sz="1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" name="표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2235214448"/>
              </p:ext>
            </p:extLst>
          </p:nvPr>
        </p:nvGraphicFramePr>
        <p:xfrm>
          <a:off x="120755" y="1158468"/>
          <a:ext cx="5815434" cy="560332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901618"/>
                <a:gridCol w="2434368"/>
                <a:gridCol w="2479448"/>
              </a:tblGrid>
              <a:tr h="554392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6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</a:t>
                      </a:r>
                      <a:endParaRPr lang="ko-KR" altLang="en-US" sz="16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6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 (5’→ 3’)</a:t>
                      </a:r>
                      <a:endParaRPr lang="ko-KR" altLang="en-US" sz="16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marL="0" marR="0" indent="0" algn="l" defTabSz="1280251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6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 (5’→ 3’)</a:t>
                      </a:r>
                      <a:endParaRPr lang="ko-KR" altLang="en-US" sz="1600" b="1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latinLnBrk="1"/>
                      <a:endParaRPr lang="ko-KR" altLang="en-US" sz="16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246" marR="57246" marT="29700" marB="29700"/>
                </a:tc>
              </a:tr>
              <a:tr h="623691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X2</a:t>
                      </a:r>
                    </a:p>
                    <a:p>
                      <a:pPr latinLnBrk="1"/>
                      <a:r>
                        <a:rPr lang="en-US" altLang="ko-KR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human)</a:t>
                      </a:r>
                    </a:p>
                    <a:p>
                      <a:pPr latinLnBrk="1"/>
                      <a:endParaRPr lang="ko-KR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b="1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GACGAGGTCAACGATCCC</a:t>
                      </a:r>
                      <a:endParaRPr lang="ko-KR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b="1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TCGCCTGGTTCTAGGAAT</a:t>
                      </a:r>
                      <a:endParaRPr lang="ko-KR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246" marR="57246" marT="29700" marB="29700"/>
                </a:tc>
              </a:tr>
              <a:tr h="442524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X2</a:t>
                      </a:r>
                    </a:p>
                    <a:p>
                      <a:pPr latinLnBrk="1"/>
                      <a:r>
                        <a:rPr lang="en-US" altLang="ko-KR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mouse)</a:t>
                      </a:r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b="1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CGA TCGTTCTGCCAATA</a:t>
                      </a:r>
                      <a:endParaRPr lang="ko-KR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b="1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TTGATTTAGTCGGCCTGG</a:t>
                      </a:r>
                      <a:endParaRPr lang="ko-KR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246" marR="57246" marT="29700" marB="29700"/>
                </a:tc>
              </a:tr>
              <a:tr h="442524">
                <a:tc>
                  <a:txBody>
                    <a:bodyPr/>
                    <a:lstStyle/>
                    <a:p>
                      <a:pPr marL="0" marR="0" indent="0" algn="l" defTabSz="1280251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PS18</a:t>
                      </a:r>
                      <a:endParaRPr lang="ko-KR" altLang="en-US" sz="1200" b="1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TAACCCGTTGAACCCCATT</a:t>
                      </a:r>
                      <a:endParaRPr lang="ko-KR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ATCCAATCGGTAGTAGCG</a:t>
                      </a:r>
                      <a:endParaRPr lang="ko-KR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246" marR="57246" marT="29700" marB="29700"/>
                </a:tc>
              </a:tr>
              <a:tr h="442524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RT1</a:t>
                      </a:r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CAGTGTCATGGTTCCTTTGC</a:t>
                      </a:r>
                      <a:endParaRPr lang="ko-KR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AGGGCACCGAGGAACTAC</a:t>
                      </a:r>
                      <a:endParaRPr lang="ko-KR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246" marR="57246" marT="29700" marB="29700"/>
                </a:tc>
              </a:tr>
              <a:tr h="442524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CAT</a:t>
                      </a:r>
                      <a:endParaRPr lang="ko-KR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1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CCTGTGGCATTGCTGGAG</a:t>
                      </a:r>
                      <a:endParaRPr lang="ko-KR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b="1" kern="0" dirty="0">
                          <a:effectLst/>
                          <a:latin typeface="Arial" panose="020B0604020202020204" pitchFamily="34" charset="0"/>
                          <a:ea typeface="맑은 고딕"/>
                          <a:cs typeface="Arial" panose="020B0604020202020204" pitchFamily="34" charset="0"/>
                        </a:rPr>
                        <a:t>TTCCACAGGAACATCCAGTCC</a:t>
                      </a:r>
                      <a:endParaRPr lang="ko-KR" sz="1200" b="1" kern="100" dirty="0">
                        <a:effectLst/>
                        <a:latin typeface="Arial" panose="020B0604020202020204" pitchFamily="34" charset="0"/>
                        <a:ea typeface="맑은 고딕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</a:tr>
              <a:tr h="442524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S1</a:t>
                      </a:r>
                      <a:endParaRPr lang="ko-KR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1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GGACGCACGTCACTTTACT</a:t>
                      </a:r>
                      <a:endParaRPr lang="ko-KR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1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CAGATGACGCTTGATATGGG</a:t>
                      </a:r>
                      <a:endParaRPr lang="ko-KR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246" marR="57246" marT="29700" marB="29700"/>
                </a:tc>
              </a:tr>
              <a:tr h="442524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S2</a:t>
                      </a:r>
                      <a:endParaRPr lang="ko-KR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1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CCTGGGACCAATGGTTTTGA</a:t>
                      </a:r>
                      <a:endParaRPr lang="ko-KR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1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CACACACAGCAGGAAGTACC</a:t>
                      </a:r>
                      <a:endParaRPr lang="ko-KR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246" marR="57246" marT="29700" marB="29700"/>
                </a:tc>
              </a:tr>
              <a:tr h="442524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LS</a:t>
                      </a:r>
                      <a:endParaRPr lang="ko-KR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1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CGTGTTGGGCTACCTGATT</a:t>
                      </a:r>
                      <a:endParaRPr lang="ko-KR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1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GGCCCAGTTTCGAGCAATA</a:t>
                      </a:r>
                      <a:endParaRPr lang="ko-KR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246" marR="57246" marT="29700" marB="29700"/>
                </a:tc>
              </a:tr>
              <a:tr h="442524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PMT1</a:t>
                      </a:r>
                      <a:endParaRPr lang="ko-KR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1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AGACCCGATTCCTGTGCAA</a:t>
                      </a:r>
                      <a:endParaRPr lang="ko-KR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1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AGATTGGCCAAGGTTGGGA</a:t>
                      </a:r>
                      <a:endParaRPr lang="ko-KR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246" marR="57246" marT="29700" marB="29700"/>
                </a:tc>
              </a:tr>
              <a:tr h="442524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b="1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ffazin</a:t>
                      </a:r>
                      <a:endParaRPr lang="ko-KR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1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GCTCATTGAGAACCGAGGC</a:t>
                      </a:r>
                      <a:endParaRPr lang="ko-KR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1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CGGAGTTTTAGGATCCCCC</a:t>
                      </a:r>
                      <a:endParaRPr lang="ko-KR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246" marR="57246" marT="29700" marB="29700"/>
                </a:tc>
              </a:tr>
              <a:tr h="442524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veolin-1</a:t>
                      </a:r>
                      <a:endParaRPr lang="ko-KR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1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GCACACCAAGGAGATTGAC</a:t>
                      </a:r>
                      <a:endParaRPr lang="ko-KR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1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GATGCCGTCGAAACTGTGT</a:t>
                      </a:r>
                      <a:endParaRPr lang="ko-KR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246" marR="57246" marT="29700" marB="29700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xmlns="" val="11876437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874432" y="7853775"/>
            <a:ext cx="2263001" cy="299896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15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3.</a:t>
            </a:r>
            <a:endParaRPr lang="ko-KR" altLang="en-US" sz="1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표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113435576"/>
              </p:ext>
            </p:extLst>
          </p:nvPr>
        </p:nvGraphicFramePr>
        <p:xfrm>
          <a:off x="84642" y="135705"/>
          <a:ext cx="5927220" cy="747135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93726"/>
                <a:gridCol w="1487669"/>
                <a:gridCol w="1764020"/>
                <a:gridCol w="1481805"/>
              </a:tblGrid>
              <a:tr h="455394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300" dirty="0" smtClean="0"/>
                        <a:t>Name</a:t>
                      </a:r>
                      <a:endParaRPr lang="ko-KR" altLang="en-US" sz="1300" dirty="0"/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300" dirty="0" smtClean="0"/>
                        <a:t>Company</a:t>
                      </a:r>
                      <a:endParaRPr lang="ko-KR" altLang="en-US" sz="1300" dirty="0"/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300" dirty="0" smtClean="0"/>
                        <a:t>Host</a:t>
                      </a:r>
                      <a:endParaRPr lang="ko-KR" altLang="en-US" sz="1300" dirty="0"/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300" dirty="0" smtClean="0"/>
                        <a:t>Experiments</a:t>
                      </a:r>
                      <a:r>
                        <a:rPr lang="en-US" altLang="ko-KR" sz="1300" baseline="0" dirty="0" smtClean="0"/>
                        <a:t> (dilution factor)</a:t>
                      </a:r>
                      <a:endParaRPr lang="ko-KR" altLang="en-US" sz="1300" dirty="0"/>
                    </a:p>
                  </a:txBody>
                  <a:tcPr marL="57246" marR="57246" marT="29700" marB="29700"/>
                </a:tc>
              </a:tr>
              <a:tr h="240897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000" b="1" dirty="0" smtClean="0"/>
                        <a:t>Caveolin-1</a:t>
                      </a:r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BD 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Science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5963" marR="5963" marT="6187" marB="0" anchor="ctr"/>
                </a:tc>
                <a:tc>
                  <a:txBody>
                    <a:bodyPr/>
                    <a:lstStyle/>
                    <a:p>
                      <a:pPr marL="0" marR="0" indent="0" algn="l" defTabSz="1280251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smtClean="0"/>
                        <a:t>Mouse</a:t>
                      </a:r>
                      <a:r>
                        <a:rPr lang="en-US" altLang="ko-KR" sz="1000" b="1" baseline="0" dirty="0" smtClean="0"/>
                        <a:t> monoclonal</a:t>
                      </a:r>
                      <a:endParaRPr lang="ko-KR" altLang="en-US" sz="1000" b="1" dirty="0" smtClean="0"/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marL="0" marR="0" indent="0" algn="l" defTabSz="1280251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smtClean="0"/>
                        <a:t>IB (1:2000)</a:t>
                      </a:r>
                      <a:endParaRPr lang="ko-KR" altLang="en-US" sz="1000" b="1" dirty="0" smtClean="0"/>
                    </a:p>
                  </a:txBody>
                  <a:tcPr marL="57246" marR="57246" marT="29700" marB="29700"/>
                </a:tc>
              </a:tr>
              <a:tr h="240897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000" b="1" dirty="0" smtClean="0"/>
                        <a:t>Cyclin</a:t>
                      </a:r>
                      <a:r>
                        <a:rPr lang="en-US" altLang="ko-KR" sz="1000" b="1" baseline="0" dirty="0" smtClean="0"/>
                        <a:t> D1</a:t>
                      </a:r>
                      <a:endParaRPr lang="ko-KR" altLang="en-US" sz="1000" b="1" dirty="0"/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marL="0" marR="0" indent="0" algn="l" defTabSz="1280251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anta Cruz</a:t>
                      </a:r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marL="0" marR="0" indent="0" algn="l" defTabSz="1280251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smtClean="0"/>
                        <a:t>Mouse</a:t>
                      </a:r>
                      <a:r>
                        <a:rPr lang="en-US" altLang="ko-KR" sz="1000" b="1" baseline="0" dirty="0" smtClean="0"/>
                        <a:t> monoclonal</a:t>
                      </a:r>
                      <a:endParaRPr lang="ko-KR" altLang="en-US" sz="1000" b="1" dirty="0" smtClean="0"/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marL="0" marR="0" indent="0" algn="l" defTabSz="1280251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smtClean="0"/>
                        <a:t>IB (1:1000)</a:t>
                      </a:r>
                      <a:endParaRPr lang="ko-KR" altLang="en-US" sz="1000" b="1" dirty="0" smtClean="0"/>
                    </a:p>
                  </a:txBody>
                  <a:tcPr marL="57246" marR="57246" marT="29700" marB="29700"/>
                </a:tc>
              </a:tr>
              <a:tr h="240897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000" b="1" dirty="0" smtClean="0"/>
                        <a:t>Cyclin A</a:t>
                      </a:r>
                      <a:endParaRPr lang="ko-KR" altLang="en-US" sz="1000" b="1" dirty="0"/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marL="0" marR="0" indent="0" algn="l" defTabSz="1280251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anta Cruz</a:t>
                      </a:r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marL="0" marR="0" indent="0" algn="l" defTabSz="1280251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smtClean="0"/>
                        <a:t>Rabbit polyclonal</a:t>
                      </a:r>
                      <a:endParaRPr lang="ko-KR" altLang="en-US" sz="1000" b="1" dirty="0" smtClean="0"/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marL="0" marR="0" indent="0" algn="l" defTabSz="1280251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smtClean="0"/>
                        <a:t>IB (1:1000)</a:t>
                      </a:r>
                      <a:endParaRPr lang="ko-KR" altLang="en-US" sz="1000" b="1" dirty="0" smtClean="0"/>
                    </a:p>
                  </a:txBody>
                  <a:tcPr marL="57246" marR="57246" marT="29700" marB="29700"/>
                </a:tc>
              </a:tr>
              <a:tr h="240897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000" b="1" dirty="0" smtClean="0"/>
                        <a:t>Cyclin B</a:t>
                      </a:r>
                      <a:endParaRPr lang="ko-KR" altLang="en-US" sz="1000" b="1" dirty="0"/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marL="0" marR="0" indent="0" algn="l" defTabSz="1280251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anta Cruz</a:t>
                      </a:r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marL="0" marR="0" indent="0" algn="l" defTabSz="1280251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smtClean="0"/>
                        <a:t>Rabbit polyclonal</a:t>
                      </a:r>
                      <a:endParaRPr lang="ko-KR" altLang="en-US" sz="1000" b="1" dirty="0" smtClean="0"/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marL="0" marR="0" indent="0" algn="l" defTabSz="1280251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smtClean="0"/>
                        <a:t>IB (1:1000)</a:t>
                      </a:r>
                      <a:endParaRPr lang="ko-KR" altLang="en-US" sz="1000" b="1" dirty="0" smtClean="0"/>
                    </a:p>
                  </a:txBody>
                  <a:tcPr marL="57246" marR="57246" marT="29700" marB="29700"/>
                </a:tc>
              </a:tr>
              <a:tr h="240897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000" b="1" dirty="0" smtClean="0"/>
                        <a:t>CDK</a:t>
                      </a:r>
                      <a:r>
                        <a:rPr lang="en-US" altLang="ko-KR" sz="1000" b="1" baseline="0" dirty="0" smtClean="0"/>
                        <a:t> </a:t>
                      </a:r>
                      <a:r>
                        <a:rPr lang="en-US" altLang="ko-KR" sz="1000" b="1" dirty="0" smtClean="0"/>
                        <a:t>2</a:t>
                      </a:r>
                      <a:endParaRPr lang="ko-KR" altLang="en-US" sz="1000" b="1" dirty="0"/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marL="0" marR="0" indent="0" algn="l" defTabSz="1280251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anta Cruz</a:t>
                      </a:r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marL="0" marR="0" indent="0" algn="l" defTabSz="1280251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smtClean="0"/>
                        <a:t>Rabbit polyclonal</a:t>
                      </a:r>
                      <a:endParaRPr lang="ko-KR" altLang="en-US" sz="1000" b="1" dirty="0" smtClean="0"/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marL="0" marR="0" indent="0" algn="l" defTabSz="1280251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smtClean="0"/>
                        <a:t>IB (1:1000)</a:t>
                      </a:r>
                      <a:endParaRPr lang="ko-KR" altLang="en-US" sz="1000" b="1" dirty="0" smtClean="0"/>
                    </a:p>
                  </a:txBody>
                  <a:tcPr marL="57246" marR="57246" marT="29700" marB="29700"/>
                </a:tc>
              </a:tr>
              <a:tr h="240897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000" b="1" dirty="0" smtClean="0"/>
                        <a:t>CDK</a:t>
                      </a:r>
                      <a:r>
                        <a:rPr lang="ko-KR" altLang="en-US" sz="1000" b="1" baseline="0" dirty="0" smtClean="0"/>
                        <a:t> </a:t>
                      </a:r>
                      <a:r>
                        <a:rPr lang="en-US" altLang="ko-KR" sz="1000" b="1" dirty="0" smtClean="0"/>
                        <a:t>4</a:t>
                      </a:r>
                      <a:endParaRPr lang="ko-KR" altLang="en-US" sz="1000" b="1" dirty="0"/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marL="0" marR="0" indent="0" algn="l" defTabSz="1280251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anta Cruz</a:t>
                      </a:r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marL="0" marR="0" indent="0" algn="l" defTabSz="1280251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smtClean="0"/>
                        <a:t>Rabbit polyclonal</a:t>
                      </a:r>
                      <a:endParaRPr lang="ko-KR" altLang="en-US" sz="1000" b="1" dirty="0" smtClean="0"/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marL="0" marR="0" indent="0" algn="l" defTabSz="1280251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smtClean="0"/>
                        <a:t>IB (1:1000)</a:t>
                      </a:r>
                      <a:endParaRPr lang="ko-KR" altLang="en-US" sz="1000" b="1" dirty="0" smtClean="0"/>
                    </a:p>
                  </a:txBody>
                  <a:tcPr marL="57246" marR="57246" marT="29700" marB="29700"/>
                </a:tc>
              </a:tr>
              <a:tr h="240897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000" b="1" dirty="0" smtClean="0"/>
                        <a:t>p-</a:t>
                      </a:r>
                      <a:r>
                        <a:rPr lang="en-US" altLang="ko-KR" sz="1000" b="1" dirty="0" err="1" smtClean="0"/>
                        <a:t>pRb</a:t>
                      </a:r>
                      <a:endParaRPr lang="ko-KR" altLang="en-US" sz="1000" b="1" dirty="0"/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000" b="1" dirty="0" smtClean="0"/>
                        <a:t>Cell Signaling</a:t>
                      </a:r>
                      <a:endParaRPr lang="ko-KR" altLang="en-US" sz="1000" b="1" dirty="0"/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marL="0" marR="0" indent="0" algn="l" defTabSz="1280251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smtClean="0"/>
                        <a:t>Rabbit polyclonal</a:t>
                      </a:r>
                      <a:endParaRPr lang="ko-KR" altLang="en-US" sz="1000" b="1" dirty="0" smtClean="0"/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marL="0" marR="0" indent="0" algn="l" defTabSz="1280251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smtClean="0"/>
                        <a:t>IB (1:1000)</a:t>
                      </a:r>
                      <a:endParaRPr lang="ko-KR" altLang="en-US" sz="1000" b="1" dirty="0" smtClean="0"/>
                    </a:p>
                  </a:txBody>
                  <a:tcPr marL="57246" marR="57246" marT="29700" marB="29700"/>
                </a:tc>
              </a:tr>
              <a:tr h="240897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000" b="1" dirty="0" smtClean="0"/>
                        <a:t>p53</a:t>
                      </a:r>
                      <a:endParaRPr lang="ko-KR" altLang="en-US" sz="1000" b="1" dirty="0"/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marL="0" marR="0" indent="0" algn="l" defTabSz="1280251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anta Cruz</a:t>
                      </a:r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marL="0" marR="0" indent="0" algn="l" defTabSz="1280251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smtClean="0"/>
                        <a:t>Rabbit polyclonal</a:t>
                      </a:r>
                      <a:endParaRPr lang="ko-KR" altLang="en-US" sz="1000" b="1" dirty="0" smtClean="0"/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marL="0" marR="0" indent="0" algn="l" defTabSz="1280251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smtClean="0"/>
                        <a:t>IB (1:1000)</a:t>
                      </a:r>
                      <a:endParaRPr lang="ko-KR" altLang="en-US" sz="1000" b="1" dirty="0" smtClean="0"/>
                    </a:p>
                  </a:txBody>
                  <a:tcPr marL="57246" marR="57246" marT="29700" marB="29700"/>
                </a:tc>
              </a:tr>
              <a:tr h="240897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000" b="1" dirty="0" smtClean="0"/>
                        <a:t>p21</a:t>
                      </a:r>
                      <a:endParaRPr lang="ko-KR" altLang="en-US" sz="1000" b="1" dirty="0"/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marL="0" marR="0" indent="0" algn="l" defTabSz="1280251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anta Cruz</a:t>
                      </a:r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marL="0" marR="0" indent="0" algn="l" defTabSz="1280251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smtClean="0"/>
                        <a:t>Mouse</a:t>
                      </a:r>
                      <a:r>
                        <a:rPr lang="en-US" altLang="ko-KR" sz="1000" b="1" baseline="0" dirty="0" smtClean="0"/>
                        <a:t> monoclonal</a:t>
                      </a:r>
                      <a:endParaRPr lang="ko-KR" altLang="en-US" sz="1000" b="1" dirty="0" smtClean="0"/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marL="0" marR="0" indent="0" algn="l" defTabSz="1280251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smtClean="0"/>
                        <a:t>IB (1:1000)</a:t>
                      </a:r>
                      <a:endParaRPr lang="ko-KR" altLang="en-US" sz="1000" b="1" dirty="0" smtClean="0"/>
                    </a:p>
                  </a:txBody>
                  <a:tcPr marL="57246" marR="57246" marT="29700" marB="29700"/>
                </a:tc>
              </a:tr>
              <a:tr h="240897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000" b="1" dirty="0" smtClean="0"/>
                        <a:t>Actin</a:t>
                      </a:r>
                      <a:endParaRPr lang="ko-KR" altLang="en-US" sz="1000" b="1" dirty="0"/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Santa Cruz</a:t>
                      </a:r>
                    </a:p>
                  </a:txBody>
                  <a:tcPr marL="5963" marR="5963" marT="6187" marB="0" anchor="ctr"/>
                </a:tc>
                <a:tc>
                  <a:txBody>
                    <a:bodyPr/>
                    <a:lstStyle/>
                    <a:p>
                      <a:pPr marL="0" marR="0" indent="0" algn="l" defTabSz="1280251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smtClean="0"/>
                        <a:t>Mouse</a:t>
                      </a:r>
                      <a:r>
                        <a:rPr lang="en-US" altLang="ko-KR" sz="1000" b="1" baseline="0" dirty="0" smtClean="0"/>
                        <a:t> monoclonal</a:t>
                      </a:r>
                      <a:endParaRPr lang="ko-KR" altLang="en-US" sz="1000" b="1" dirty="0" smtClean="0"/>
                    </a:p>
                  </a:txBody>
                  <a:tcPr marL="5963" marR="5963" marT="6187" marB="0" anchor="ctr"/>
                </a:tc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000" b="1" dirty="0" smtClean="0"/>
                        <a:t>IB (1:1000)</a:t>
                      </a:r>
                      <a:endParaRPr lang="ko-KR" altLang="en-US" sz="1000" b="1" dirty="0"/>
                    </a:p>
                  </a:txBody>
                  <a:tcPr marL="57246" marR="57246" marT="29700" marB="29700"/>
                </a:tc>
              </a:tr>
              <a:tr h="240897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000" b="1" dirty="0" smtClean="0"/>
                        <a:t>NDUFV1</a:t>
                      </a:r>
                      <a:endParaRPr lang="ko-KR" altLang="en-US" sz="1000" b="1" dirty="0"/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Santa Cruz</a:t>
                      </a:r>
                    </a:p>
                  </a:txBody>
                  <a:tcPr marL="5963" marR="5963" marT="6187" marB="0" anchor="ctr"/>
                </a:tc>
                <a:tc>
                  <a:txBody>
                    <a:bodyPr/>
                    <a:lstStyle/>
                    <a:p>
                      <a:pPr marL="0" marR="0" indent="0" algn="l" defTabSz="1280251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smtClean="0"/>
                        <a:t>Rabbit polyclonal</a:t>
                      </a:r>
                      <a:endParaRPr lang="ko-KR" altLang="en-US" sz="1000" b="1" dirty="0" smtClean="0"/>
                    </a:p>
                  </a:txBody>
                  <a:tcPr marL="5963" marR="5963" marT="6187" marB="0" anchor="ctr"/>
                </a:tc>
                <a:tc>
                  <a:txBody>
                    <a:bodyPr/>
                    <a:lstStyle/>
                    <a:p>
                      <a:pPr marL="0" marR="0" indent="0" algn="l" defTabSz="1280251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smtClean="0"/>
                        <a:t>IB (1:500)</a:t>
                      </a:r>
                      <a:endParaRPr lang="ko-KR" altLang="en-US" sz="1000" b="1" dirty="0" smtClean="0"/>
                    </a:p>
                  </a:txBody>
                  <a:tcPr marL="57246" marR="57246" marT="29700" marB="29700"/>
                </a:tc>
              </a:tr>
              <a:tr h="240897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000" b="1" dirty="0" smtClean="0"/>
                        <a:t>NDUFS3</a:t>
                      </a:r>
                      <a:endParaRPr lang="ko-KR" altLang="en-US" sz="1000" b="1" dirty="0"/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Santa Cruz</a:t>
                      </a:r>
                    </a:p>
                  </a:txBody>
                  <a:tcPr marL="5963" marR="5963" marT="6187" marB="0" anchor="ctr"/>
                </a:tc>
                <a:tc>
                  <a:txBody>
                    <a:bodyPr/>
                    <a:lstStyle/>
                    <a:p>
                      <a:pPr marL="0" marR="0" indent="0" algn="l" defTabSz="1280251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smtClean="0"/>
                        <a:t>Mouse</a:t>
                      </a:r>
                      <a:r>
                        <a:rPr lang="en-US" altLang="ko-KR" sz="1000" b="1" baseline="0" dirty="0" smtClean="0"/>
                        <a:t> monoclonal</a:t>
                      </a:r>
                      <a:endParaRPr lang="ko-KR" altLang="en-US" sz="1000" b="1" dirty="0" smtClean="0"/>
                    </a:p>
                  </a:txBody>
                  <a:tcPr marL="5963" marR="5963" marT="6187" marB="0" anchor="ctr"/>
                </a:tc>
                <a:tc>
                  <a:txBody>
                    <a:bodyPr/>
                    <a:lstStyle/>
                    <a:p>
                      <a:pPr marL="0" marR="0" indent="0" algn="l" defTabSz="1280251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smtClean="0"/>
                        <a:t>IB (1:500)</a:t>
                      </a:r>
                      <a:endParaRPr lang="ko-KR" altLang="en-US" sz="1000" b="1" dirty="0" smtClean="0"/>
                    </a:p>
                  </a:txBody>
                  <a:tcPr marL="57246" marR="57246" marT="29700" marB="29700"/>
                </a:tc>
              </a:tr>
              <a:tr h="240897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000" b="1" dirty="0" smtClean="0"/>
                        <a:t>NDUFV2</a:t>
                      </a:r>
                      <a:endParaRPr lang="ko-KR" altLang="en-US" sz="1000" b="1" dirty="0"/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Santa Cruz</a:t>
                      </a:r>
                    </a:p>
                  </a:txBody>
                  <a:tcPr marL="5963" marR="5963" marT="6187" marB="0" anchor="ctr"/>
                </a:tc>
                <a:tc>
                  <a:txBody>
                    <a:bodyPr/>
                    <a:lstStyle/>
                    <a:p>
                      <a:pPr marL="0" marR="0" indent="0" algn="l" defTabSz="1280251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smtClean="0"/>
                        <a:t>Rabbit polyclonal</a:t>
                      </a:r>
                      <a:endParaRPr lang="ko-KR" altLang="en-US" sz="1000" b="1" dirty="0" smtClean="0"/>
                    </a:p>
                  </a:txBody>
                  <a:tcPr marL="5963" marR="5963" marT="6187" marB="0" anchor="ctr"/>
                </a:tc>
                <a:tc>
                  <a:txBody>
                    <a:bodyPr/>
                    <a:lstStyle/>
                    <a:p>
                      <a:pPr marL="0" marR="0" indent="0" algn="l" defTabSz="1280251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smtClean="0"/>
                        <a:t>IB (1:500)</a:t>
                      </a:r>
                      <a:endParaRPr lang="ko-KR" altLang="en-US" sz="1000" b="1" dirty="0" smtClean="0"/>
                    </a:p>
                  </a:txBody>
                  <a:tcPr marL="57246" marR="57246" marT="29700" marB="29700"/>
                </a:tc>
              </a:tr>
              <a:tr h="240897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000" b="1" dirty="0" smtClean="0"/>
                        <a:t>SDHB</a:t>
                      </a:r>
                      <a:endParaRPr lang="ko-KR" altLang="en-US" sz="1000" b="1" dirty="0"/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Abcam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5963" marR="5963" marT="6187" marB="0" anchor="ctr"/>
                </a:tc>
                <a:tc>
                  <a:txBody>
                    <a:bodyPr/>
                    <a:lstStyle/>
                    <a:p>
                      <a:pPr marL="0" marR="0" indent="0" algn="l" defTabSz="1280251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smtClean="0"/>
                        <a:t>Mouse</a:t>
                      </a:r>
                      <a:r>
                        <a:rPr lang="en-US" altLang="ko-KR" sz="1000" b="1" baseline="0" dirty="0" smtClean="0"/>
                        <a:t> monoclonal</a:t>
                      </a:r>
                      <a:endParaRPr lang="ko-KR" altLang="en-US" sz="1000" b="1" dirty="0" smtClean="0"/>
                    </a:p>
                  </a:txBody>
                  <a:tcPr marL="5963" marR="5963" marT="6187" marB="0" anchor="ctr"/>
                </a:tc>
                <a:tc>
                  <a:txBody>
                    <a:bodyPr/>
                    <a:lstStyle/>
                    <a:p>
                      <a:pPr marL="0" marR="0" indent="0" algn="l" defTabSz="1280251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smtClean="0"/>
                        <a:t>IB (1:2000)</a:t>
                      </a:r>
                      <a:endParaRPr lang="ko-KR" altLang="en-US" sz="1000" b="1" dirty="0" smtClean="0"/>
                    </a:p>
                  </a:txBody>
                  <a:tcPr marL="57246" marR="57246" marT="29700" marB="29700"/>
                </a:tc>
              </a:tr>
              <a:tr h="240897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000" b="1" dirty="0" smtClean="0"/>
                        <a:t>UQCRC2</a:t>
                      </a:r>
                      <a:endParaRPr lang="ko-KR" altLang="en-US" sz="1000" b="1" dirty="0"/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Abcam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5963" marR="5963" marT="6187" marB="0" anchor="ctr"/>
                </a:tc>
                <a:tc>
                  <a:txBody>
                    <a:bodyPr/>
                    <a:lstStyle/>
                    <a:p>
                      <a:pPr marL="0" marR="0" indent="0" algn="l" defTabSz="1280251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smtClean="0"/>
                        <a:t>Mouse</a:t>
                      </a:r>
                      <a:r>
                        <a:rPr lang="en-US" altLang="ko-KR" sz="1000" b="1" baseline="0" dirty="0" smtClean="0"/>
                        <a:t> monoclonal</a:t>
                      </a:r>
                      <a:endParaRPr lang="ko-KR" altLang="en-US" sz="1000" b="1" dirty="0" smtClean="0"/>
                    </a:p>
                  </a:txBody>
                  <a:tcPr marL="5963" marR="5963" marT="6187" marB="0" anchor="ctr"/>
                </a:tc>
                <a:tc>
                  <a:txBody>
                    <a:bodyPr/>
                    <a:lstStyle/>
                    <a:p>
                      <a:pPr marL="0" marR="0" indent="0" algn="l" defTabSz="1280251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smtClean="0"/>
                        <a:t>IB (1:2000)</a:t>
                      </a:r>
                      <a:endParaRPr lang="ko-KR" altLang="en-US" sz="1000" b="1" dirty="0" smtClean="0"/>
                    </a:p>
                  </a:txBody>
                  <a:tcPr marL="57246" marR="57246" marT="29700" marB="29700"/>
                </a:tc>
              </a:tr>
              <a:tr h="240897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000" b="1" dirty="0" smtClean="0"/>
                        <a:t>Subunit </a:t>
                      </a:r>
                      <a:r>
                        <a:rPr lang="en-US" altLang="ko-KR" sz="1000" b="1" dirty="0" err="1" smtClean="0"/>
                        <a:t>Vb</a:t>
                      </a:r>
                      <a:endParaRPr lang="ko-KR" altLang="en-US" sz="1000" b="1" dirty="0"/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invitrogen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5963" marR="5963" marT="6187" marB="0" anchor="ctr"/>
                </a:tc>
                <a:tc>
                  <a:txBody>
                    <a:bodyPr/>
                    <a:lstStyle/>
                    <a:p>
                      <a:pPr marL="0" marR="0" indent="0" algn="l" defTabSz="1280251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smtClean="0"/>
                        <a:t>Mouse</a:t>
                      </a:r>
                      <a:r>
                        <a:rPr lang="en-US" altLang="ko-KR" sz="1000" b="1" baseline="0" dirty="0" smtClean="0"/>
                        <a:t> monoclonal</a:t>
                      </a:r>
                      <a:endParaRPr lang="ko-KR" altLang="en-US" sz="1000" b="1" dirty="0" smtClean="0"/>
                    </a:p>
                  </a:txBody>
                  <a:tcPr marL="5963" marR="5963" marT="6187" marB="0" anchor="ctr"/>
                </a:tc>
                <a:tc>
                  <a:txBody>
                    <a:bodyPr/>
                    <a:lstStyle/>
                    <a:p>
                      <a:pPr marL="0" marR="0" indent="0" algn="l" defTabSz="1280251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smtClean="0"/>
                        <a:t>IB (1:500)</a:t>
                      </a:r>
                      <a:endParaRPr lang="ko-KR" altLang="en-US" sz="1000" b="1" dirty="0" smtClean="0"/>
                    </a:p>
                  </a:txBody>
                  <a:tcPr marL="57246" marR="57246" marT="29700" marB="29700"/>
                </a:tc>
              </a:tr>
              <a:tr h="240897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000" b="1" dirty="0" smtClean="0"/>
                        <a:t>ATP </a:t>
                      </a:r>
                      <a:r>
                        <a:rPr lang="en-US" altLang="ko-KR" sz="1000" b="1" dirty="0" smtClean="0">
                          <a:latin typeface="Symbol" panose="05050102010706020507" pitchFamily="18" charset="2"/>
                        </a:rPr>
                        <a:t>b</a:t>
                      </a:r>
                      <a:endParaRPr lang="ko-KR" altLang="en-US" sz="1000" b="1" dirty="0">
                        <a:latin typeface="Symbol" panose="05050102010706020507" pitchFamily="18" charset="2"/>
                      </a:endParaRPr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000" b="1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bcam</a:t>
                      </a:r>
                      <a:endParaRPr lang="en-US" altLang="ko-KR" sz="1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963" marR="5963" marT="6187" marB="0" anchor="ctr"/>
                </a:tc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000" b="1" dirty="0" smtClean="0"/>
                        <a:t>Mouse</a:t>
                      </a:r>
                      <a:r>
                        <a:rPr lang="en-US" altLang="ko-KR" sz="1000" b="1" baseline="0" dirty="0" smtClean="0"/>
                        <a:t> monoclonal</a:t>
                      </a:r>
                      <a:endParaRPr lang="ko-KR" altLang="en-US" sz="1000" b="1" dirty="0"/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marL="0" marR="0" indent="0" algn="l" defTabSz="1280251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smtClean="0"/>
                        <a:t>IB (1:2000)</a:t>
                      </a:r>
                      <a:endParaRPr lang="ko-KR" altLang="en-US" sz="1000" b="1" dirty="0" smtClean="0"/>
                    </a:p>
                  </a:txBody>
                  <a:tcPr marL="57246" marR="57246" marT="29700" marB="29700"/>
                </a:tc>
              </a:tr>
              <a:tr h="240897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000" b="1" dirty="0" smtClean="0"/>
                        <a:t>SIRT1</a:t>
                      </a:r>
                      <a:endParaRPr lang="ko-KR" altLang="en-US" sz="1000" b="1" dirty="0"/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Upstate</a:t>
                      </a:r>
                    </a:p>
                  </a:txBody>
                  <a:tcPr marL="5963" marR="5963" marT="6187" marB="0" anchor="ctr"/>
                </a:tc>
                <a:tc>
                  <a:txBody>
                    <a:bodyPr/>
                    <a:lstStyle/>
                    <a:p>
                      <a:pPr marL="0" marR="0" indent="0" algn="l" defTabSz="1280251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smtClean="0"/>
                        <a:t>Rabbit polyclonal</a:t>
                      </a:r>
                      <a:endParaRPr lang="ko-KR" altLang="en-US" sz="1000" b="1" dirty="0" smtClean="0"/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marL="0" marR="0" indent="0" algn="l" defTabSz="1280251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smtClean="0"/>
                        <a:t>IB (1:1000)</a:t>
                      </a:r>
                      <a:endParaRPr lang="ko-KR" altLang="en-US" sz="1000" b="1" dirty="0" smtClean="0"/>
                    </a:p>
                  </a:txBody>
                  <a:tcPr marL="57246" marR="57246" marT="29700" marB="29700"/>
                </a:tc>
              </a:tr>
              <a:tr h="240897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000" b="1" dirty="0" smtClean="0"/>
                        <a:t>Ac-p53 (k382)</a:t>
                      </a:r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marL="0" marR="0" indent="0" algn="l" defTabSz="1280251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smtClean="0"/>
                        <a:t>Cell Signaling</a:t>
                      </a:r>
                      <a:endParaRPr lang="ko-KR" altLang="en-US" sz="1000" b="1" dirty="0" smtClean="0"/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marL="0" marR="0" indent="0" algn="l" defTabSz="1280251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smtClean="0"/>
                        <a:t>Rabbit polyclonal</a:t>
                      </a:r>
                      <a:endParaRPr lang="ko-KR" altLang="en-US" sz="1000" b="1" dirty="0" smtClean="0"/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marL="0" marR="0" indent="0" algn="l" defTabSz="1280251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smtClean="0"/>
                        <a:t>IB (1:500)</a:t>
                      </a:r>
                      <a:endParaRPr lang="ko-KR" altLang="en-US" sz="1000" b="1" dirty="0" smtClean="0"/>
                    </a:p>
                  </a:txBody>
                  <a:tcPr marL="57246" marR="57246" marT="29700" marB="29700"/>
                </a:tc>
              </a:tr>
              <a:tr h="240897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000" b="1" dirty="0" smtClean="0"/>
                        <a:t>Ac-p53 (k379)</a:t>
                      </a:r>
                      <a:endParaRPr lang="ko-KR" altLang="en-US" sz="1000" b="1" dirty="0"/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marL="0" marR="0" indent="0" algn="l" defTabSz="1280251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smtClean="0"/>
                        <a:t>Cell Signaling</a:t>
                      </a:r>
                      <a:endParaRPr lang="ko-KR" altLang="en-US" sz="1000" b="1" dirty="0" smtClean="0"/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marL="0" marR="0" indent="0" algn="l" defTabSz="1280251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smtClean="0"/>
                        <a:t>Rabbit polyclonal</a:t>
                      </a:r>
                      <a:endParaRPr lang="ko-KR" altLang="en-US" sz="1000" b="1" dirty="0" smtClean="0"/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marL="0" marR="0" indent="0" algn="l" defTabSz="1280251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smtClean="0"/>
                        <a:t>IB (1:1000))</a:t>
                      </a:r>
                      <a:endParaRPr lang="ko-KR" altLang="en-US" sz="1000" b="1" dirty="0" smtClean="0"/>
                    </a:p>
                  </a:txBody>
                  <a:tcPr marL="57246" marR="57246" marT="29700" marB="29700"/>
                </a:tc>
              </a:tr>
              <a:tr h="240897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000" b="1" dirty="0" smtClean="0"/>
                        <a:t>LCLAT</a:t>
                      </a:r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000" b="1" dirty="0" err="1" smtClean="0"/>
                        <a:t>Abcam</a:t>
                      </a:r>
                      <a:endParaRPr lang="ko-KR" altLang="en-US" sz="1000" b="1" dirty="0"/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000" b="1" dirty="0" smtClean="0"/>
                        <a:t>Rabbit polyclonal</a:t>
                      </a:r>
                      <a:endParaRPr lang="ko-KR" altLang="en-US" sz="1000" b="1" dirty="0"/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000" b="1" dirty="0" smtClean="0"/>
                        <a:t>IB (1:1000)</a:t>
                      </a:r>
                      <a:endParaRPr lang="ko-KR" altLang="en-US" sz="1000" b="1" dirty="0"/>
                    </a:p>
                  </a:txBody>
                  <a:tcPr marL="57246" marR="57246" marT="29700" marB="29700"/>
                </a:tc>
              </a:tr>
              <a:tr h="240897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000" b="1" dirty="0" smtClean="0"/>
                        <a:t>CDS1</a:t>
                      </a:r>
                      <a:endParaRPr lang="ko-KR" altLang="en-US" sz="1000" b="1" dirty="0"/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marL="0" marR="0" indent="0" algn="l" defTabSz="1280251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err="1" smtClean="0"/>
                        <a:t>Abcam</a:t>
                      </a:r>
                      <a:endParaRPr lang="ko-KR" altLang="en-US" sz="1000" b="1" dirty="0" smtClean="0"/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000" b="1" dirty="0" smtClean="0"/>
                        <a:t>Rabbit polyclonal</a:t>
                      </a:r>
                      <a:endParaRPr lang="ko-KR" altLang="en-US" sz="1000" b="1" dirty="0"/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marL="0" marR="0" indent="0" algn="l" defTabSz="1280251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smtClean="0"/>
                        <a:t>IB (1:1000)</a:t>
                      </a:r>
                      <a:endParaRPr lang="ko-KR" altLang="en-US" sz="1000" b="1" dirty="0" smtClean="0"/>
                    </a:p>
                  </a:txBody>
                  <a:tcPr marL="57246" marR="57246" marT="29700" marB="29700"/>
                </a:tc>
              </a:tr>
              <a:tr h="240897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000" b="1" dirty="0" smtClean="0"/>
                        <a:t>CDS2</a:t>
                      </a:r>
                      <a:endParaRPr lang="ko-KR" altLang="en-US" sz="1000" b="1" dirty="0"/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000" b="1" dirty="0" smtClean="0"/>
                        <a:t>Santa Cruz</a:t>
                      </a:r>
                      <a:endParaRPr lang="ko-KR" altLang="en-US" sz="1000" b="1" dirty="0"/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000" b="1" dirty="0" smtClean="0"/>
                        <a:t>Rabbit polyclonal</a:t>
                      </a:r>
                      <a:endParaRPr lang="ko-KR" altLang="en-US" sz="1000" b="1" dirty="0"/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marL="0" marR="0" indent="0" algn="l" defTabSz="1280251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smtClean="0"/>
                        <a:t>IB (1:500)</a:t>
                      </a:r>
                      <a:endParaRPr lang="ko-KR" altLang="en-US" sz="1000" b="1" dirty="0" smtClean="0"/>
                    </a:p>
                  </a:txBody>
                  <a:tcPr marL="57246" marR="57246" marT="29700" marB="29700"/>
                </a:tc>
              </a:tr>
              <a:tr h="240897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000" b="1" dirty="0" smtClean="0"/>
                        <a:t>CRLS</a:t>
                      </a:r>
                      <a:endParaRPr lang="ko-KR" altLang="en-US" sz="1000" b="1" dirty="0"/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marL="0" marR="0" indent="0" algn="l" defTabSz="1280251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err="1" smtClean="0"/>
                        <a:t>Abcam</a:t>
                      </a:r>
                      <a:endParaRPr lang="ko-KR" altLang="en-US" sz="1000" b="1" dirty="0" smtClean="0"/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000" b="1" dirty="0" smtClean="0"/>
                        <a:t>Rabbit polyclonal</a:t>
                      </a:r>
                      <a:endParaRPr lang="ko-KR" altLang="en-US" sz="1000" b="1" dirty="0"/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marL="0" marR="0" indent="0" algn="l" defTabSz="1280251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smtClean="0"/>
                        <a:t>IB (1:1000)</a:t>
                      </a:r>
                      <a:endParaRPr lang="ko-KR" altLang="en-US" sz="1000" b="1" dirty="0" smtClean="0"/>
                    </a:p>
                  </a:txBody>
                  <a:tcPr marL="57246" marR="57246" marT="29700" marB="29700"/>
                </a:tc>
              </a:tr>
              <a:tr h="240897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000" b="1" dirty="0" smtClean="0"/>
                        <a:t>PTPMT1</a:t>
                      </a:r>
                      <a:endParaRPr lang="ko-KR" altLang="en-US" sz="1000" b="1" dirty="0"/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marL="0" marR="0" indent="0" algn="l" defTabSz="1280251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err="1" smtClean="0"/>
                        <a:t>Abcam</a:t>
                      </a:r>
                      <a:endParaRPr lang="ko-KR" altLang="en-US" sz="1000" b="1" dirty="0" smtClean="0"/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000" b="1" dirty="0" smtClean="0"/>
                        <a:t>Rabbit polyclonal</a:t>
                      </a:r>
                      <a:endParaRPr lang="ko-KR" altLang="en-US" sz="1000" b="1" dirty="0"/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marL="0" marR="0" indent="0" algn="l" defTabSz="1280251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smtClean="0"/>
                        <a:t>IB (1:1000)</a:t>
                      </a:r>
                      <a:endParaRPr lang="ko-KR" altLang="en-US" sz="1000" b="1" dirty="0" smtClean="0"/>
                    </a:p>
                  </a:txBody>
                  <a:tcPr marL="57246" marR="57246" marT="29700" marB="29700"/>
                </a:tc>
              </a:tr>
              <a:tr h="240897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000" b="1" dirty="0" smtClean="0"/>
                        <a:t>TAZ</a:t>
                      </a:r>
                      <a:endParaRPr lang="ko-KR" altLang="en-US" sz="1000" b="1" dirty="0"/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000" b="1" dirty="0" smtClean="0"/>
                        <a:t>Santa Cruz</a:t>
                      </a:r>
                      <a:endParaRPr lang="ko-KR" altLang="en-US" sz="1000" b="1" dirty="0"/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000" b="1" dirty="0" smtClean="0"/>
                        <a:t>Mouse</a:t>
                      </a:r>
                      <a:r>
                        <a:rPr lang="en-US" altLang="ko-KR" sz="1000" b="1" baseline="0" dirty="0" smtClean="0"/>
                        <a:t> monoclonal</a:t>
                      </a:r>
                      <a:endParaRPr lang="ko-KR" altLang="en-US" sz="1000" b="1" dirty="0"/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marL="0" marR="0" indent="0" algn="l" defTabSz="1280251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smtClean="0"/>
                        <a:t>IB (1:250)</a:t>
                      </a:r>
                      <a:endParaRPr lang="ko-KR" altLang="en-US" sz="1000" b="1" dirty="0" smtClean="0"/>
                    </a:p>
                  </a:txBody>
                  <a:tcPr marL="57246" marR="57246" marT="29700" marB="29700"/>
                </a:tc>
              </a:tr>
              <a:tr h="376195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000" b="1" dirty="0" smtClean="0"/>
                        <a:t>HRP-conjugated anti-mouse IgG</a:t>
                      </a:r>
                      <a:endParaRPr lang="ko-KR" altLang="en-US" sz="1000" b="1" dirty="0"/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000" b="1" dirty="0" smtClean="0"/>
                        <a:t>Pierce</a:t>
                      </a:r>
                      <a:endParaRPr lang="ko-KR" altLang="en-US" sz="1000" b="1" dirty="0"/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000" b="1" dirty="0" smtClean="0"/>
                        <a:t>Goat polyclonal</a:t>
                      </a:r>
                      <a:endParaRPr lang="ko-KR" altLang="en-US" sz="1000" b="1" dirty="0"/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marL="0" marR="0" indent="0" algn="l" defTabSz="1280251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smtClean="0"/>
                        <a:t>IB (1:10000~20000)</a:t>
                      </a:r>
                      <a:endParaRPr lang="ko-KR" altLang="en-US" sz="1000" b="1" dirty="0" smtClean="0"/>
                    </a:p>
                  </a:txBody>
                  <a:tcPr marL="57246" marR="57246" marT="29700" marB="29700"/>
                </a:tc>
              </a:tr>
              <a:tr h="376195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000" b="1" dirty="0" smtClean="0"/>
                        <a:t>HRP-conjugated anti-rabbit IgG</a:t>
                      </a:r>
                      <a:endParaRPr lang="ko-KR" altLang="en-US" sz="1000" b="1" dirty="0"/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000" b="1" dirty="0" smtClean="0"/>
                        <a:t>Pierce</a:t>
                      </a:r>
                      <a:endParaRPr lang="ko-KR" altLang="en-US" sz="1000" b="1" dirty="0"/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marL="0" marR="0" indent="0" algn="l" defTabSz="1280251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smtClean="0"/>
                        <a:t>Goat polyclonal</a:t>
                      </a:r>
                      <a:endParaRPr lang="ko-KR" altLang="en-US" sz="1000" b="1" dirty="0" smtClean="0"/>
                    </a:p>
                    <a:p>
                      <a:pPr algn="l" latinLnBrk="1"/>
                      <a:endParaRPr lang="ko-KR" altLang="en-US" sz="1000" b="1" dirty="0"/>
                    </a:p>
                  </a:txBody>
                  <a:tcPr marL="57246" marR="57246" marT="29700" marB="29700"/>
                </a:tc>
                <a:tc>
                  <a:txBody>
                    <a:bodyPr/>
                    <a:lstStyle/>
                    <a:p>
                      <a:pPr marL="0" marR="0" indent="0" algn="l" defTabSz="1280251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smtClean="0"/>
                        <a:t>IB (1:10000~20000)</a:t>
                      </a:r>
                      <a:endParaRPr lang="ko-KR" altLang="en-US" sz="1000" b="1" dirty="0" smtClean="0"/>
                    </a:p>
                    <a:p>
                      <a:pPr marL="0" marR="0" indent="0" algn="l" defTabSz="1280251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ko-KR" altLang="en-US" sz="1000" b="1" dirty="0" smtClean="0"/>
                    </a:p>
                  </a:txBody>
                  <a:tcPr marL="57246" marR="57246" marT="29700" marB="29700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xmlns="" val="7760744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334</TotalTime>
  <Words>461</Words>
  <Application>Microsoft Office PowerPoint</Application>
  <PresentationFormat>Custom</PresentationFormat>
  <Paragraphs>177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테마</vt:lpstr>
      <vt:lpstr>Slide 1</vt:lpstr>
      <vt:lpstr>Slide 2</vt:lpstr>
      <vt:lpstr>Slide 3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Dongmin</dc:creator>
  <cp:lastModifiedBy>loginwb3</cp:lastModifiedBy>
  <cp:revision>104</cp:revision>
  <dcterms:created xsi:type="dcterms:W3CDTF">2016-03-14T13:13:35Z</dcterms:created>
  <dcterms:modified xsi:type="dcterms:W3CDTF">2017-04-05T10:35:34Z</dcterms:modified>
</cp:coreProperties>
</file>